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907588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099200" cy="10234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4021200" y="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  <a:ea typeface="ＭＳ Ｐゴシック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D266805-05DF-4F88-82FA-1B1AB596D393}" type="datetime">
              <a:rPr b="0" lang="en-GB" sz="12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29/08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220840" y="767880"/>
            <a:ext cx="2657520" cy="38372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4680" rIns="94680" tIns="47160" bIns="471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  <a:ea typeface="ＭＳ Ｐゴシック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077AF81-CE56-4843-BDAC-3444F7BD0E0B}" type="slidenum">
              <a:rPr b="0" lang="en-GB" sz="12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PlaceHolder 1"/>
          <p:cNvSpPr>
            <a:spLocks noGrp="1"/>
          </p:cNvSpPr>
          <p:nvPr>
            <p:ph type="sldImg"/>
          </p:nvPr>
        </p:nvSpPr>
        <p:spPr>
          <a:xfrm>
            <a:off x="2220840" y="768240"/>
            <a:ext cx="2657520" cy="3837240"/>
          </a:xfrm>
          <a:prstGeom prst="rect">
            <a:avLst/>
          </a:prstGeom>
          <a:ln w="0">
            <a:noFill/>
          </a:ln>
        </p:spPr>
      </p:sp>
      <p:sp>
        <p:nvSpPr>
          <p:cNvPr id="79" name="PlaceHolder 2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S.Fig. 1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Gray scale without ‘flattening’ the imag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All panels from a single x-ray film No.2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Slide Number Placeholder 3"/>
          <p:cNvSpPr/>
          <p:nvPr/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4680" rIns="94680" tIns="47160" bIns="4716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B1E1940-2178-4F9E-9C2D-C923E8668589}" type="slidenum">
              <a:rPr b="0" lang="en-GB" sz="12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76E192-6226-4FEC-A3BD-FB0798B5DA0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645F97-7244-426B-8389-7AF109011A9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859181-35D4-4D67-A1A6-209D18FA125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6AE83A-0111-40CF-A14A-61F5339F718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9D3FDB-92F5-48BE-9625-093204BBA55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D1DED3-FC2B-4AF4-870D-4B972639331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02E1B0-99A7-400E-AB20-F55B04C15FD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E36263-1017-4734-A921-2CAC80CDFF1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3743A6-F114-4E59-93D2-94C2AD7C257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C6DDAD-F9CF-44CC-BBA3-BCC5F68022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28B1DB-5F9C-444D-B2E7-04B9573356C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08C850-521B-4205-A64F-148B1249D0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  <a:ea typeface="ＭＳ Ｐゴシック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9FF3284-7FA6-4C2C-A8A3-4758080557B5}" type="datetime">
              <a:rPr b="0" lang="en-GB" sz="1200" spc="-1" strike="noStrike">
                <a:solidFill>
                  <a:srgbClr val="898989"/>
                </a:solidFill>
                <a:latin typeface="Calibri"/>
                <a:ea typeface="ＭＳ Ｐゴシック"/>
              </a:rPr>
              <a:t>29/08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  <a:ea typeface="ＭＳ Ｐゴシック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BD19AE2-C674-4C98-B7CC-4C721DBBFF6E}" type="slidenum">
              <a:rPr b="0" lang="en-GB" sz="1200" spc="-1" strike="noStrike">
                <a:solidFill>
                  <a:srgbClr val="898989"/>
                </a:solidFill>
                <a:latin typeface="Calibri"/>
                <a:ea typeface="ＭＳ Ｐゴシック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1.xml"/><Relationship Id="rId10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3"/>
          <p:cNvSpPr/>
          <p:nvPr/>
        </p:nvSpPr>
        <p:spPr>
          <a:xfrm>
            <a:off x="3141720" y="8594640"/>
            <a:ext cx="2971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Ruhanen et al., Supplementary Figure 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Picture 49" descr=""/>
          <p:cNvPicPr/>
          <p:nvPr/>
        </p:nvPicPr>
        <p:blipFill>
          <a:blip r:embed="rId1"/>
          <a:stretch/>
        </p:blipFill>
        <p:spPr>
          <a:xfrm>
            <a:off x="1452600" y="4446720"/>
            <a:ext cx="3573360" cy="177156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50" descr=""/>
          <p:cNvPicPr/>
          <p:nvPr/>
        </p:nvPicPr>
        <p:blipFill>
          <a:blip r:embed="rId2"/>
          <a:stretch/>
        </p:blipFill>
        <p:spPr>
          <a:xfrm>
            <a:off x="1523880" y="6567480"/>
            <a:ext cx="3560760" cy="1666800"/>
          </a:xfrm>
          <a:prstGeom prst="rect">
            <a:avLst/>
          </a:prstGeom>
          <a:ln w="0">
            <a:noFill/>
          </a:ln>
        </p:spPr>
      </p:pic>
      <p:sp>
        <p:nvSpPr>
          <p:cNvPr id="51" name="TextBox 3"/>
          <p:cNvSpPr/>
          <p:nvPr/>
        </p:nvSpPr>
        <p:spPr>
          <a:xfrm>
            <a:off x="2049480" y="4233960"/>
            <a:ext cx="64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ontr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3"/>
          <p:cNvSpPr/>
          <p:nvPr/>
        </p:nvSpPr>
        <p:spPr>
          <a:xfrm>
            <a:off x="3705120" y="4233960"/>
            <a:ext cx="649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Symbol"/>
                <a:ea typeface="Symbol"/>
              </a:rPr>
              <a:t></a:t>
            </a:r>
            <a:r>
              <a:rPr b="0" lang="en-GB" sz="10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0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cell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3"/>
          <p:cNvSpPr/>
          <p:nvPr/>
        </p:nvSpPr>
        <p:spPr>
          <a:xfrm>
            <a:off x="5084640" y="6610320"/>
            <a:ext cx="9367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outhern hybridis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3"/>
          <p:cNvSpPr/>
          <p:nvPr/>
        </p:nvSpPr>
        <p:spPr>
          <a:xfrm>
            <a:off x="5084640" y="4417920"/>
            <a:ext cx="115272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Gel image of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double-stranded DNA arc under UV illuminato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3"/>
          <p:cNvSpPr/>
          <p:nvPr/>
        </p:nvSpPr>
        <p:spPr>
          <a:xfrm>
            <a:off x="1154160" y="4202280"/>
            <a:ext cx="247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3"/>
          <p:cNvSpPr/>
          <p:nvPr/>
        </p:nvSpPr>
        <p:spPr>
          <a:xfrm>
            <a:off x="1154160" y="6327720"/>
            <a:ext cx="247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3"/>
          <p:cNvSpPr/>
          <p:nvPr/>
        </p:nvSpPr>
        <p:spPr>
          <a:xfrm>
            <a:off x="2049480" y="6343560"/>
            <a:ext cx="64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ontr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3"/>
          <p:cNvSpPr/>
          <p:nvPr/>
        </p:nvSpPr>
        <p:spPr>
          <a:xfrm>
            <a:off x="3705120" y="6343560"/>
            <a:ext cx="649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Symbol"/>
                <a:ea typeface="Symbol"/>
              </a:rPr>
              <a:t></a:t>
            </a:r>
            <a:r>
              <a:rPr b="0" lang="en-GB" sz="10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0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cell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9"/>
          <p:cNvSpPr/>
          <p:nvPr/>
        </p:nvSpPr>
        <p:spPr>
          <a:xfrm>
            <a:off x="1557000" y="1454040"/>
            <a:ext cx="951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DNA ligase II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eft Brace 13"/>
          <p:cNvSpPr/>
          <p:nvPr/>
        </p:nvSpPr>
        <p:spPr>
          <a:xfrm>
            <a:off x="2424240" y="1311120"/>
            <a:ext cx="61920" cy="538200"/>
          </a:xfrm>
          <a:custGeom>
            <a:avLst/>
            <a:gdLst>
              <a:gd name="textAreaLeft" fmla="*/ 39600 w 61920"/>
              <a:gd name="textAreaRight" fmla="*/ 62280 w 61920"/>
              <a:gd name="textAreaTop" fmla="*/ 1440 h 538200"/>
              <a:gd name="textAreaBottom" fmla="*/ 536760 h 5382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104"/>
                  <a:pt x="10800" y="207"/>
                </a:cubicBezTo>
                <a:lnTo>
                  <a:pt x="10800" y="10593"/>
                </a:lnTo>
                <a:cubicBezTo>
                  <a:pt x="10800" y="10697"/>
                  <a:pt x="5400" y="10800"/>
                  <a:pt x="0" y="10800"/>
                </a:cubicBezTo>
                <a:cubicBezTo>
                  <a:pt x="5400" y="10800"/>
                  <a:pt x="10800" y="10904"/>
                  <a:pt x="10800" y="11007"/>
                </a:cubicBezTo>
                <a:lnTo>
                  <a:pt x="10800" y="21393"/>
                </a:lnTo>
                <a:cubicBezTo>
                  <a:pt x="10800" y="21497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9"/>
          <p:cNvSpPr/>
          <p:nvPr/>
        </p:nvSpPr>
        <p:spPr>
          <a:xfrm>
            <a:off x="2547000" y="1114560"/>
            <a:ext cx="328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9"/>
          <p:cNvSpPr/>
          <p:nvPr/>
        </p:nvSpPr>
        <p:spPr>
          <a:xfrm>
            <a:off x="2826360" y="111600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LII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9"/>
          <p:cNvSpPr/>
          <p:nvPr/>
        </p:nvSpPr>
        <p:spPr>
          <a:xfrm>
            <a:off x="3232800" y="1114560"/>
            <a:ext cx="328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9"/>
          <p:cNvSpPr/>
          <p:nvPr/>
        </p:nvSpPr>
        <p:spPr>
          <a:xfrm>
            <a:off x="3518640" y="111600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LII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9"/>
          <p:cNvSpPr/>
          <p:nvPr/>
        </p:nvSpPr>
        <p:spPr>
          <a:xfrm>
            <a:off x="1977480" y="1114560"/>
            <a:ext cx="616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dsRNA: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Straight Connector 19"/>
          <p:cNvSpPr/>
          <p:nvPr/>
        </p:nvSpPr>
        <p:spPr>
          <a:xfrm>
            <a:off x="2604960" y="1139760"/>
            <a:ext cx="4874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Straight Connector 20"/>
          <p:cNvSpPr/>
          <p:nvPr/>
        </p:nvSpPr>
        <p:spPr>
          <a:xfrm>
            <a:off x="3298680" y="1139760"/>
            <a:ext cx="4874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5"/>
          <p:cNvSpPr/>
          <p:nvPr/>
        </p:nvSpPr>
        <p:spPr>
          <a:xfrm>
            <a:off x="2518560" y="920880"/>
            <a:ext cx="715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Mt-1 (R2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5"/>
          <p:cNvSpPr/>
          <p:nvPr/>
        </p:nvSpPr>
        <p:spPr>
          <a:xfrm>
            <a:off x="3213000" y="920880"/>
            <a:ext cx="715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Mt-2 (R2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9"/>
          <p:cNvSpPr/>
          <p:nvPr/>
        </p:nvSpPr>
        <p:spPr>
          <a:xfrm>
            <a:off x="1836360" y="1898640"/>
            <a:ext cx="615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HSP 6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1" name="Picture 90" descr=""/>
          <p:cNvPicPr/>
          <p:nvPr/>
        </p:nvPicPr>
        <p:blipFill>
          <a:blip r:embed="rId3"/>
          <a:stretch/>
        </p:blipFill>
        <p:spPr>
          <a:xfrm>
            <a:off x="2519280" y="1603440"/>
            <a:ext cx="642960" cy="2412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72" name="Picture 91" descr=""/>
          <p:cNvPicPr/>
          <p:nvPr/>
        </p:nvPicPr>
        <p:blipFill>
          <a:blip r:embed="rId4"/>
          <a:stretch/>
        </p:blipFill>
        <p:spPr>
          <a:xfrm>
            <a:off x="2516040" y="1322280"/>
            <a:ext cx="642960" cy="2415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73" name="Picture 92" descr=""/>
          <p:cNvPicPr/>
          <p:nvPr/>
        </p:nvPicPr>
        <p:blipFill>
          <a:blip r:embed="rId5"/>
          <a:stretch/>
        </p:blipFill>
        <p:spPr>
          <a:xfrm>
            <a:off x="2494080" y="1887480"/>
            <a:ext cx="682560" cy="2984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74" name="Picture 93" descr=""/>
          <p:cNvPicPr/>
          <p:nvPr/>
        </p:nvPicPr>
        <p:blipFill>
          <a:blip r:embed="rId6"/>
          <a:stretch/>
        </p:blipFill>
        <p:spPr>
          <a:xfrm>
            <a:off x="3260880" y="1328760"/>
            <a:ext cx="554040" cy="2095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75" name="Picture 94" descr=""/>
          <p:cNvPicPr/>
          <p:nvPr/>
        </p:nvPicPr>
        <p:blipFill>
          <a:blip r:embed="rId7"/>
          <a:stretch/>
        </p:blipFill>
        <p:spPr>
          <a:xfrm>
            <a:off x="3260880" y="1611360"/>
            <a:ext cx="554040" cy="2095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76" name="Picture 95" descr=""/>
          <p:cNvPicPr/>
          <p:nvPr/>
        </p:nvPicPr>
        <p:blipFill>
          <a:blip r:embed="rId8"/>
          <a:stretch/>
        </p:blipFill>
        <p:spPr>
          <a:xfrm>
            <a:off x="3230640" y="1878120"/>
            <a:ext cx="639720" cy="3078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77" name="TextBox 3"/>
          <p:cNvSpPr/>
          <p:nvPr/>
        </p:nvSpPr>
        <p:spPr>
          <a:xfrm>
            <a:off x="3138480" y="2505240"/>
            <a:ext cx="2971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Ruhanen et al., Supplementary Figure 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5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0-17T14:52:44Z</dcterms:created>
  <dc:creator>rmgzyta</dc:creator>
  <dc:description/>
  <dc:language>en-US</dc:language>
  <cp:lastModifiedBy>rmgzyta</cp:lastModifiedBy>
  <dcterms:modified xsi:type="dcterms:W3CDTF">2011-06-24T13:45:20Z</dcterms:modified>
  <cp:revision>252</cp:revision>
  <dc:subject/>
  <dc:title>Slide 1</dc:title>
</cp:coreProperties>
</file>